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58" r:id="rId6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9F97E0B-D026-471C-A0AE-ED355C0C37E2}" v="59" dt="2023-11-22T02:19:22.0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olinebedinzanatta" userId="S::carolinebedinzanatta_gmail.com#ext#@norce.onmicrosoft.com::0943be76-14c4-4bbc-84af-2eb3d93f7ef9" providerId="AD" clId="Web-{D9F97E0B-D026-471C-A0AE-ED355C0C37E2}"/>
    <pc:docChg chg="modSld">
      <pc:chgData name="carolinebedinzanatta" userId="S::carolinebedinzanatta_gmail.com#ext#@norce.onmicrosoft.com::0943be76-14c4-4bbc-84af-2eb3d93f7ef9" providerId="AD" clId="Web-{D9F97E0B-D026-471C-A0AE-ED355C0C37E2}" dt="2023-11-22T02:19:21.151" v="37" actId="14100"/>
      <pc:docMkLst>
        <pc:docMk/>
      </pc:docMkLst>
      <pc:sldChg chg="addSp delSp modSp">
        <pc:chgData name="carolinebedinzanatta" userId="S::carolinebedinzanatta_gmail.com#ext#@norce.onmicrosoft.com::0943be76-14c4-4bbc-84af-2eb3d93f7ef9" providerId="AD" clId="Web-{D9F97E0B-D026-471C-A0AE-ED355C0C37E2}" dt="2023-11-22T02:19:00.448" v="26" actId="1076"/>
        <pc:sldMkLst>
          <pc:docMk/>
          <pc:sldMk cId="530974090" sldId="257"/>
        </pc:sldMkLst>
        <pc:spChg chg="mod">
          <ac:chgData name="carolinebedinzanatta" userId="S::carolinebedinzanatta_gmail.com#ext#@norce.onmicrosoft.com::0943be76-14c4-4bbc-84af-2eb3d93f7ef9" providerId="AD" clId="Web-{D9F97E0B-D026-471C-A0AE-ED355C0C37E2}" dt="2023-11-22T02:19:00.448" v="26" actId="1076"/>
          <ac:spMkLst>
            <pc:docMk/>
            <pc:sldMk cId="530974090" sldId="257"/>
            <ac:spMk id="2" creationId="{00000000-0000-0000-0000-000000000000}"/>
          </ac:spMkLst>
        </pc:spChg>
        <pc:spChg chg="mod">
          <ac:chgData name="carolinebedinzanatta" userId="S::carolinebedinzanatta_gmail.com#ext#@norce.onmicrosoft.com::0943be76-14c4-4bbc-84af-2eb3d93f7ef9" providerId="AD" clId="Web-{D9F97E0B-D026-471C-A0AE-ED355C0C37E2}" dt="2023-11-22T02:18:53.807" v="25" actId="1076"/>
          <ac:spMkLst>
            <pc:docMk/>
            <pc:sldMk cId="530974090" sldId="257"/>
            <ac:spMk id="4" creationId="{387573DA-0B45-7C85-E735-7841A37C861E}"/>
          </ac:spMkLst>
        </pc:spChg>
        <pc:spChg chg="add del">
          <ac:chgData name="carolinebedinzanatta" userId="S::carolinebedinzanatta_gmail.com#ext#@norce.onmicrosoft.com::0943be76-14c4-4bbc-84af-2eb3d93f7ef9" providerId="AD" clId="Web-{D9F97E0B-D026-471C-A0AE-ED355C0C37E2}" dt="2023-11-22T02:18:30.994" v="7"/>
          <ac:spMkLst>
            <pc:docMk/>
            <pc:sldMk cId="530974090" sldId="257"/>
            <ac:spMk id="6" creationId="{ACD90824-4903-484C-FEA1-E6430FD56D6E}"/>
          </ac:spMkLst>
        </pc:spChg>
      </pc:sldChg>
      <pc:sldChg chg="modSp">
        <pc:chgData name="carolinebedinzanatta" userId="S::carolinebedinzanatta_gmail.com#ext#@norce.onmicrosoft.com::0943be76-14c4-4bbc-84af-2eb3d93f7ef9" providerId="AD" clId="Web-{D9F97E0B-D026-471C-A0AE-ED355C0C37E2}" dt="2023-11-22T02:19:21.151" v="37" actId="14100"/>
        <pc:sldMkLst>
          <pc:docMk/>
          <pc:sldMk cId="1745395275" sldId="258"/>
        </pc:sldMkLst>
        <pc:spChg chg="mod">
          <ac:chgData name="carolinebedinzanatta" userId="S::carolinebedinzanatta_gmail.com#ext#@norce.onmicrosoft.com::0943be76-14c4-4bbc-84af-2eb3d93f7ef9" providerId="AD" clId="Web-{D9F97E0B-D026-471C-A0AE-ED355C0C37E2}" dt="2023-11-22T02:19:21.151" v="37" actId="14100"/>
          <ac:spMkLst>
            <pc:docMk/>
            <pc:sldMk cId="1745395275" sldId="258"/>
            <ac:spMk id="6" creationId="{387573DA-0B45-7C85-E735-7841A37C861E}"/>
          </ac:spMkLst>
        </pc:spChg>
        <pc:spChg chg="mod">
          <ac:chgData name="carolinebedinzanatta" userId="S::carolinebedinzanatta_gmail.com#ext#@norce.onmicrosoft.com::0943be76-14c4-4bbc-84af-2eb3d93f7ef9" providerId="AD" clId="Web-{D9F97E0B-D026-471C-A0AE-ED355C0C37E2}" dt="2023-11-22T02:19:05.667" v="27" actId="1076"/>
          <ac:spMkLst>
            <pc:docMk/>
            <pc:sldMk cId="1745395275" sldId="258"/>
            <ac:spMk id="7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47981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56280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55026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77041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39831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54492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17316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52399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48050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57235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47210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D7F168-250C-4E33-A239-D6AA98A8A849}" type="datetimeFigureOut">
              <a:rPr lang="pt-BR" smtClean="0"/>
              <a:t>29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70584-BBDC-4BCE-B0A9-E604B5FFC4DB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31840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5C30006-5258-EFAA-A1ED-FC8BFE5E06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pt-BR" dirty="0"/>
          </a:p>
        </p:txBody>
      </p:sp>
      <p:pic>
        <p:nvPicPr>
          <p:cNvPr id="5" name="Imagem 4">
            <a:extLst>
              <a:ext uri="{FF2B5EF4-FFF2-40B4-BE49-F238E27FC236}">
                <a16:creationId xmlns:a16="http://schemas.microsoft.com/office/drawing/2014/main" id="{432B893B-9910-A572-C7FE-E8859D051B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692" y="1069589"/>
            <a:ext cx="11997058" cy="5624883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387573DA-0B45-7C85-E735-7841A37C861E}"/>
              </a:ext>
            </a:extLst>
          </p:cNvPr>
          <p:cNvSpPr txBox="1"/>
          <p:nvPr/>
        </p:nvSpPr>
        <p:spPr>
          <a:xfrm>
            <a:off x="1751291" y="591260"/>
            <a:ext cx="10092994" cy="43088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2200" dirty="0">
                <a:latin typeface="Arial"/>
                <a:cs typeface="Arial"/>
              </a:rPr>
              <a:t>In-silico PCR Results for the grf1-3 CRISPR-Cas9 Amplicon</a:t>
            </a:r>
            <a:endParaRPr lang="pt-BR" sz="2200" dirty="0">
              <a:latin typeface="Arial"/>
              <a:cs typeface="Arial"/>
            </a:endParaRPr>
          </a:p>
        </p:txBody>
      </p:sp>
      <p:sp>
        <p:nvSpPr>
          <p:cNvPr id="2" name="CaixaDeTexto 1"/>
          <p:cNvSpPr txBox="1"/>
          <p:nvPr/>
        </p:nvSpPr>
        <p:spPr>
          <a:xfrm>
            <a:off x="419100" y="560482"/>
            <a:ext cx="838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pt-B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094AE5B-E61E-202C-7942-C72EDC3C6BC5}"/>
              </a:ext>
            </a:extLst>
          </p:cNvPr>
          <p:cNvSpPr txBox="1"/>
          <p:nvPr/>
        </p:nvSpPr>
        <p:spPr>
          <a:xfrm>
            <a:off x="113173" y="284701"/>
            <a:ext cx="11808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latin typeface="Arial"/>
                <a:cs typeface="Arial"/>
              </a:rPr>
              <a:t>Figure S2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0974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DB4151DD-DB22-EDBA-28F8-49F1AFEE42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" y="1181100"/>
            <a:ext cx="12046560" cy="5543550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387573DA-0B45-7C85-E735-7841A37C861E}"/>
              </a:ext>
            </a:extLst>
          </p:cNvPr>
          <p:cNvSpPr txBox="1"/>
          <p:nvPr/>
        </p:nvSpPr>
        <p:spPr>
          <a:xfrm>
            <a:off x="922244" y="319942"/>
            <a:ext cx="10429009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2400" dirty="0">
                <a:latin typeface="Arial"/>
                <a:cs typeface="Arial"/>
              </a:rPr>
              <a:t>In-silico PCR Results for the grf8-61 CRISPR-Cas9 Amplicon</a:t>
            </a:r>
            <a:endParaRPr lang="pt-BR" sz="2400" dirty="0">
              <a:latin typeface="Arial"/>
              <a:cs typeface="Arial"/>
            </a:endParaRPr>
          </a:p>
        </p:txBody>
      </p:sp>
      <p:sp>
        <p:nvSpPr>
          <p:cNvPr id="7" name="CaixaDeTexto 6"/>
          <p:cNvSpPr txBox="1"/>
          <p:nvPr/>
        </p:nvSpPr>
        <p:spPr>
          <a:xfrm>
            <a:off x="76701" y="280567"/>
            <a:ext cx="838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pt-B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53952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99BAA5980718E49810AC1F8328BFAF4" ma:contentTypeVersion="8" ma:contentTypeDescription="Crie um novo documento." ma:contentTypeScope="" ma:versionID="c8e8bed09a51a7aba4f08da3251de412">
  <xsd:schema xmlns:xsd="http://www.w3.org/2001/XMLSchema" xmlns:xs="http://www.w3.org/2001/XMLSchema" xmlns:p="http://schemas.microsoft.com/office/2006/metadata/properties" xmlns:ns2="8c7e91e5-89e1-4e22-8164-59a58d73a519" targetNamespace="http://schemas.microsoft.com/office/2006/metadata/properties" ma:root="true" ma:fieldsID="fa14da877cd68c4de1a0aa9793d626fc" ns2:_="">
    <xsd:import namespace="8c7e91e5-89e1-4e22-8164-59a58d73a51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c7e91e5-89e1-4e22-8164-59a58d73a51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2" nillable="true" ma:taxonomy="true" ma:internalName="lcf76f155ced4ddcb4097134ff3c332f" ma:taxonomyFieldName="MediaServiceImageTags" ma:displayName="Marcações de imagem" ma:readOnly="false" ma:fieldId="{5cf76f15-5ced-4ddc-b409-7134ff3c332f}" ma:taxonomyMulti="true" ma:sspId="8ff8ec43-5215-498a-a147-96446220f21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ú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c7e91e5-89e1-4e22-8164-59a58d73a519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A1AB7FD9-9865-4F19-B87C-DB0FC867DCE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DBFAEEB-C89E-4405-A45C-CF225B26A44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c7e91e5-89e1-4e22-8164-59a58d73a51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7542FB9-85F7-4BEB-9931-689F4C30B73C}">
  <ds:schemaRefs>
    <ds:schemaRef ds:uri="http://schemas.microsoft.com/office/2006/metadata/properties"/>
    <ds:schemaRef ds:uri="http://schemas.microsoft.com/office/infopath/2007/PartnerControls"/>
    <ds:schemaRef ds:uri="8c7e91e5-89e1-4e22-8164-59a58d73a519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4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o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oline</dc:creator>
  <cp:lastModifiedBy>MDPI</cp:lastModifiedBy>
  <cp:revision>16</cp:revision>
  <dcterms:created xsi:type="dcterms:W3CDTF">2023-09-20T00:54:53Z</dcterms:created>
  <dcterms:modified xsi:type="dcterms:W3CDTF">2023-11-29T03:11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9BAA5980718E49810AC1F8328BFAF4</vt:lpwstr>
  </property>
  <property fmtid="{D5CDD505-2E9C-101B-9397-08002B2CF9AE}" pid="3" name="MediaServiceImageTags">
    <vt:lpwstr/>
  </property>
</Properties>
</file>